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67" r:id="rId3"/>
    <p:sldId id="264" r:id="rId4"/>
    <p:sldId id="265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36"/>
    <p:restoredTop sz="94016"/>
  </p:normalViewPr>
  <p:slideViewPr>
    <p:cSldViewPr snapToGrid="0" snapToObjects="1">
      <p:cViewPr varScale="1">
        <p:scale>
          <a:sx n="100" d="100"/>
          <a:sy n="100" d="100"/>
        </p:scale>
        <p:origin x="160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C4688A3-3F2B-164A-B8A1-65E972AF47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1DFA11D-5534-0D4D-898C-CF5ABD80F4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1B42ED6-8FB3-4041-9CE8-597CE7D5F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3ADC8DF-BAD9-1846-B00C-5D727E5C4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C516B28-4446-364B-878E-5C91D12C27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2245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2B4F9ED-E04A-124C-BFC7-F725F4FBD6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07EEB7D-0F28-2C41-A580-36059E08F2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DFC0BB6-F240-A14B-8AE1-8B62E9B34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7DBF56E-6905-1545-8007-1F8984592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5002B45-08F1-EF42-8AD3-F0F90131F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4510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DFBCC9D-CAF4-3E45-B10E-9582CBA901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76595B0-9A98-0946-B12D-0AEDD56A9C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A32C4B8-1DBC-5C4C-AC8C-22E700803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4EF57A0-F2E3-444A-9E99-A0D83830B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D55AB72-1EAC-5E45-8AFC-4F4323CA0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7854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649F97A-95F3-2C40-815E-A5EB4EF3B5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015DD2E-6BE8-2342-8225-E681B9496B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528C75E-A89D-0349-92E8-39073663D5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AFED76D-F298-3044-BD4E-DA2229D4C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509EB60-F57B-8D46-88A3-5496A04386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936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9837BA-5A8F-744D-B33E-946FD5536C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19E51DE-597B-7449-9102-2424BD652C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6F33E0A-4038-904D-B39E-297013591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EEE66D9-2CE2-5B43-A829-E8E1DFF20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D2CB5BE-E62B-7C4A-8742-F9649F6E1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583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8811E6C-1269-C940-A504-BBA29D7889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3293A20-62EF-F743-A8E7-C805E4CEA4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3A49AB3-C2FB-F44A-AA83-DA53BD4A9A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25F5E13-DC8F-5A44-8F97-93A7643E6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BC286E2-D188-A545-A8F9-A888EC1E88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BE57CCF-ABDD-4C4F-B5A1-D5CB74A3C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473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3D06259-EE21-1349-B0BB-CDD2300CAF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82D5955-F5A1-7946-B068-AA90887F91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455AD78-B2D0-4049-8449-890E0D413E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719CE9B-3712-1048-BF28-A1F6A9D892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AAA4169-CC07-4047-889F-DB14A60854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6141A5F-5FC1-FF48-BB3D-6BEF9C419B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53B40B4-E5E3-4443-9F9B-6FF3587BA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BC55415-85C5-764A-A9BE-78AA2652D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3262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6ADCDEF-E3CB-1241-A8EA-32070D531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7397FC8-86F6-DD4B-BB3F-25D40B1EE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DA3FA9EF-FE7F-5B43-9FD2-4F04B389C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A00279C1-025F-2B49-AD75-D2FCBA5F3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952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82049FA-2078-554D-A60A-A16F4A187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FD6E82D-3290-AC44-AAE3-44106CDFB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7AB29A6-C437-4048-9B9F-E0B935B45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1892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E8B7CE3-F136-7744-8CF0-17650D9ACE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2EFA887-C65E-CE48-A1B3-382409FFD3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C80AEDD-E787-B14B-9746-3E7805624A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34F257A-4CCE-0A4F-B5DD-B42B4DA0D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910790B-47B7-DA42-87BD-3DC031650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2DF487-7356-B849-A40D-85E146E0D9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8792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1B8B6FC-BAD8-B846-8D8C-9FE81BB3F3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1E19547-36B6-A846-8B78-D5FAC99362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387C616-49B9-A74A-9847-4955A7CA85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2D03AAD-EE40-DB4E-B6A1-836BDE7F5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ABC9FC1-091C-4D4D-91C9-88F1DB40C8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C0D6CF0-4D18-E94B-AD25-BA14D04B0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0329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954B2F0-B09F-D246-BB38-F35E42A7D4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47DED01-E4ED-1C48-B56A-A8E6978C3E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0715D46-801B-7346-94DA-04E9BE5580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3D999-446A-744F-9114-84D6B8305480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A21A8E1-0329-2E45-B166-E3EB98CD3B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E3BCF80-9E03-D34C-9D56-F9E3C5E66A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ABB1E4-A920-7345-B06E-5CF9E5DF93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2014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microsoft.com/office/2007/relationships/hdphoto" Target="../media/hdphoto5.wdp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7" Type="http://schemas.microsoft.com/office/2007/relationships/hdphoto" Target="../media/hdphoto9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microsoft.com/office/2007/relationships/hdphoto" Target="../media/hdphoto8.wdp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9E28644F-AD0D-A349-9378-E6345ABF0141}"/>
              </a:ext>
            </a:extLst>
          </p:cNvPr>
          <p:cNvSpPr txBox="1"/>
          <p:nvPr/>
        </p:nvSpPr>
        <p:spPr>
          <a:xfrm>
            <a:off x="0" y="0"/>
            <a:ext cx="122159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rgbClr val="FF0000"/>
                </a:solidFill>
              </a:rPr>
              <a:t>Figure 7: PKC activation </a:t>
            </a:r>
            <a:r>
              <a:rPr lang="fr-FR" dirty="0" err="1">
                <a:solidFill>
                  <a:srgbClr val="FF0000"/>
                </a:solidFill>
              </a:rPr>
              <a:t>is</a:t>
            </a:r>
            <a:r>
              <a:rPr lang="fr-FR" dirty="0">
                <a:solidFill>
                  <a:srgbClr val="FF0000"/>
                </a:solidFill>
              </a:rPr>
              <a:t> a GPR101 signature </a:t>
            </a:r>
            <a:r>
              <a:rPr lang="fr-FR" i="1" dirty="0">
                <a:solidFill>
                  <a:srgbClr val="FF0000"/>
                </a:solidFill>
              </a:rPr>
              <a:t>in vivo</a:t>
            </a:r>
          </a:p>
          <a:p>
            <a:r>
              <a:rPr lang="fr-FR" dirty="0">
                <a:solidFill>
                  <a:srgbClr val="FF0000"/>
                </a:solidFill>
              </a:rPr>
              <a:t>Panel E: Immunofluorescence </a:t>
            </a:r>
            <a:r>
              <a:rPr lang="fr-FR" dirty="0" err="1">
                <a:solidFill>
                  <a:srgbClr val="FF0000"/>
                </a:solidFill>
              </a:rPr>
              <a:t>staining</a:t>
            </a:r>
            <a:r>
              <a:rPr lang="fr-FR" dirty="0">
                <a:solidFill>
                  <a:srgbClr val="FF0000"/>
                </a:solidFill>
              </a:rPr>
              <a:t> of </a:t>
            </a:r>
            <a:r>
              <a:rPr lang="fr-FR" dirty="0" err="1">
                <a:solidFill>
                  <a:srgbClr val="FF0000"/>
                </a:solidFill>
              </a:rPr>
              <a:t>Phospho</a:t>
            </a:r>
            <a:r>
              <a:rPr lang="fr-FR" dirty="0">
                <a:solidFill>
                  <a:srgbClr val="FF0000"/>
                </a:solidFill>
              </a:rPr>
              <a:t>-PKC alpha (Thr638) in </a:t>
            </a:r>
            <a:r>
              <a:rPr lang="fr-FR" dirty="0" err="1">
                <a:solidFill>
                  <a:srgbClr val="FF0000"/>
                </a:solidFill>
              </a:rPr>
              <a:t>Human</a:t>
            </a:r>
            <a:r>
              <a:rPr lang="fr-FR" dirty="0">
                <a:solidFill>
                  <a:srgbClr val="FF0000"/>
                </a:solidFill>
              </a:rPr>
              <a:t> XLAG </a:t>
            </a:r>
            <a:r>
              <a:rPr lang="fr-FR" dirty="0" err="1">
                <a:solidFill>
                  <a:srgbClr val="FF0000"/>
                </a:solidFill>
              </a:rPr>
              <a:t>pituitary</a:t>
            </a:r>
            <a:r>
              <a:rPr lang="fr-FR" dirty="0">
                <a:solidFill>
                  <a:srgbClr val="FF0000"/>
                </a:solidFill>
              </a:rPr>
              <a:t> </a:t>
            </a:r>
            <a:r>
              <a:rPr lang="fr-FR" dirty="0" err="1">
                <a:solidFill>
                  <a:srgbClr val="FF0000"/>
                </a:solidFill>
              </a:rPr>
              <a:t>tumors</a:t>
            </a:r>
            <a:r>
              <a:rPr lang="fr-FR" dirty="0">
                <a:solidFill>
                  <a:srgbClr val="FF0000"/>
                </a:solidFill>
              </a:rPr>
              <a:t> </a:t>
            </a:r>
            <a:r>
              <a:rPr lang="fr-FR" dirty="0" err="1">
                <a:solidFill>
                  <a:srgbClr val="FF0000"/>
                </a:solidFill>
              </a:rPr>
              <a:t>from</a:t>
            </a:r>
            <a:r>
              <a:rPr lang="fr-FR" dirty="0">
                <a:solidFill>
                  <a:srgbClr val="FF0000"/>
                </a:solidFill>
              </a:rPr>
              <a:t> 2 </a:t>
            </a:r>
            <a:r>
              <a:rPr lang="fr-FR" dirty="0" err="1">
                <a:solidFill>
                  <a:srgbClr val="FF0000"/>
                </a:solidFill>
              </a:rPr>
              <a:t>different</a:t>
            </a:r>
            <a:r>
              <a:rPr lang="fr-FR" dirty="0">
                <a:solidFill>
                  <a:srgbClr val="FF0000"/>
                </a:solidFill>
              </a:rPr>
              <a:t> patients </a:t>
            </a:r>
          </a:p>
          <a:p>
            <a:r>
              <a:rPr lang="fr-FR"/>
              <a:t>n= </a:t>
            </a:r>
            <a:r>
              <a:rPr lang="fr-FR" dirty="0"/>
              <a:t>3 </a:t>
            </a:r>
            <a:r>
              <a:rPr lang="fr-FR" dirty="0" err="1"/>
              <a:t>Human</a:t>
            </a:r>
            <a:r>
              <a:rPr lang="fr-FR" dirty="0"/>
              <a:t> patients</a:t>
            </a:r>
          </a:p>
          <a:p>
            <a:r>
              <a:rPr lang="fr-FR" dirty="0"/>
              <a:t>Photos </a:t>
            </a:r>
            <a:r>
              <a:rPr lang="fr-FR" dirty="0" err="1"/>
              <a:t>were</a:t>
            </a:r>
            <a:r>
              <a:rPr lang="fr-FR" dirty="0"/>
              <a:t> </a:t>
            </a:r>
            <a:r>
              <a:rPr lang="fr-FR" dirty="0" err="1"/>
              <a:t>taken</a:t>
            </a:r>
            <a:r>
              <a:rPr lang="fr-FR" dirty="0"/>
              <a:t> at x60 magnification (Nikon A1R microscope)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D0B5F70A-512F-994D-8A0A-55F59DF88BCA}"/>
              </a:ext>
            </a:extLst>
          </p:cNvPr>
          <p:cNvSpPr txBox="1"/>
          <p:nvPr/>
        </p:nvSpPr>
        <p:spPr>
          <a:xfrm>
            <a:off x="368301" y="3441700"/>
            <a:ext cx="675639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solidFill>
                  <a:srgbClr val="FF0000"/>
                </a:solidFill>
              </a:rPr>
              <a:t>For the detection of phospho-PKC alpha:</a:t>
            </a:r>
          </a:p>
          <a:p>
            <a:pPr marL="285750" indent="-285750">
              <a:buFontTx/>
              <a:buChar char="-"/>
            </a:pPr>
            <a:r>
              <a:rPr lang="en-US" dirty="0">
                <a:solidFill>
                  <a:srgbClr val="FF0000"/>
                </a:solidFill>
              </a:rPr>
              <a:t>Primary antibody: anti-phospho-PKC alpha (Thr638) rabbit polyclonal antibody (Life Technologies, Cat. No 44-962G, dilution 1:500)</a:t>
            </a:r>
          </a:p>
          <a:p>
            <a:pPr marL="285750" indent="-285750">
              <a:buFontTx/>
              <a:buChar char="-"/>
            </a:pPr>
            <a:r>
              <a:rPr lang="en-US" dirty="0">
                <a:solidFill>
                  <a:srgbClr val="FF0000"/>
                </a:solidFill>
              </a:rPr>
              <a:t>Secondary antibody: anti-rabbit IgG Fab2 Alexa Fluor 647 (Cell Signaling Technology, Cat. No 4414S, dilution 1:1000)</a:t>
            </a:r>
            <a:r>
              <a:rPr lang="fr-BE" dirty="0">
                <a:solidFill>
                  <a:srgbClr val="FF0000"/>
                </a:solidFill>
              </a:rPr>
              <a:t> </a:t>
            </a:r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1C5173E5-F9F3-194E-9884-B045842D533C}"/>
              </a:ext>
            </a:extLst>
          </p:cNvPr>
          <p:cNvSpPr txBox="1"/>
          <p:nvPr/>
        </p:nvSpPr>
        <p:spPr>
          <a:xfrm>
            <a:off x="368301" y="2527300"/>
            <a:ext cx="27646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u="sng" dirty="0">
                <a:solidFill>
                  <a:srgbClr val="00B0F0"/>
                </a:solidFill>
              </a:rPr>
              <a:t>For the </a:t>
            </a:r>
            <a:r>
              <a:rPr lang="fr-FR" b="1" u="sng" dirty="0" err="1">
                <a:solidFill>
                  <a:srgbClr val="00B0F0"/>
                </a:solidFill>
              </a:rPr>
              <a:t>detection</a:t>
            </a:r>
            <a:r>
              <a:rPr lang="fr-FR" b="1" u="sng" dirty="0">
                <a:solidFill>
                  <a:srgbClr val="00B0F0"/>
                </a:solidFill>
              </a:rPr>
              <a:t> of </a:t>
            </a:r>
            <a:r>
              <a:rPr lang="fr-FR" b="1" u="sng" dirty="0" err="1">
                <a:solidFill>
                  <a:srgbClr val="00B0F0"/>
                </a:solidFill>
              </a:rPr>
              <a:t>nuclei</a:t>
            </a:r>
            <a:r>
              <a:rPr lang="fr-FR" b="1" u="sng" dirty="0">
                <a:solidFill>
                  <a:srgbClr val="00B0F0"/>
                </a:solidFill>
              </a:rPr>
              <a:t>:</a:t>
            </a:r>
          </a:p>
          <a:p>
            <a:r>
              <a:rPr lang="fr-FR" dirty="0">
                <a:solidFill>
                  <a:srgbClr val="00B0F0"/>
                </a:solidFill>
              </a:rPr>
              <a:t>DAPI</a:t>
            </a:r>
          </a:p>
        </p:txBody>
      </p:sp>
    </p:spTree>
    <p:extLst>
      <p:ext uri="{BB962C8B-B14F-4D97-AF65-F5344CB8AC3E}">
        <p14:creationId xmlns:p14="http://schemas.microsoft.com/office/powerpoint/2010/main" val="13563756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83018824-520D-8F4F-A0A2-8B73C87ED7FB}"/>
              </a:ext>
            </a:extLst>
          </p:cNvPr>
          <p:cNvPicPr>
            <a:picLocks/>
          </p:cNvPicPr>
          <p:nvPr/>
        </p:nvPicPr>
        <p:blipFill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458902" y="1691704"/>
            <a:ext cx="3236400" cy="323640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F6F7A2AD-4288-564F-8744-82FC73E41962}"/>
              </a:ext>
            </a:extLst>
          </p:cNvPr>
          <p:cNvPicPr>
            <a:picLocks/>
          </p:cNvPicPr>
          <p:nvPr/>
        </p:nvPicPr>
        <p:blipFill>
          <a:blip r:embed="rId4" cstate="email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6042" y="1697284"/>
            <a:ext cx="3236400" cy="323640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3663DC37-5967-8C4D-B4B2-01CCE9982D10}"/>
              </a:ext>
            </a:extLst>
          </p:cNvPr>
          <p:cNvPicPr>
            <a:picLocks/>
          </p:cNvPicPr>
          <p:nvPr/>
        </p:nvPicPr>
        <p:blipFill>
          <a:blip r:embed="rId6" cstate="email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32472" y="1691704"/>
            <a:ext cx="3236400" cy="3236400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BF3C044B-E5B1-2745-8E76-C595506E0A78}"/>
              </a:ext>
            </a:extLst>
          </p:cNvPr>
          <p:cNvSpPr txBox="1"/>
          <p:nvPr/>
        </p:nvSpPr>
        <p:spPr>
          <a:xfrm>
            <a:off x="806042" y="1691704"/>
            <a:ext cx="984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E7C686E-6EE9-6D4D-A8CF-FF091E38B240}"/>
              </a:ext>
            </a:extLst>
          </p:cNvPr>
          <p:cNvSpPr txBox="1"/>
          <p:nvPr/>
        </p:nvSpPr>
        <p:spPr>
          <a:xfrm>
            <a:off x="7458902" y="1691704"/>
            <a:ext cx="323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C5B75D2B-6C76-604A-BFB4-BDB9FD9DF2D2}"/>
              </a:ext>
            </a:extLst>
          </p:cNvPr>
          <p:cNvSpPr txBox="1"/>
          <p:nvPr/>
        </p:nvSpPr>
        <p:spPr>
          <a:xfrm>
            <a:off x="4131961" y="1691704"/>
            <a:ext cx="319575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-PKCɒ</a:t>
            </a:r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fr-F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Thr638)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0DE5862F-2CE6-8A49-A1D4-671FB5A652E0}"/>
              </a:ext>
            </a:extLst>
          </p:cNvPr>
          <p:cNvSpPr txBox="1"/>
          <p:nvPr/>
        </p:nvSpPr>
        <p:spPr>
          <a:xfrm>
            <a:off x="806042" y="4939264"/>
            <a:ext cx="1744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cale</a:t>
            </a:r>
            <a:r>
              <a:rPr lang="fr-FR" dirty="0"/>
              <a:t> bar= 10µm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2D964678-691B-AE42-ACCC-8F26D6092E25}"/>
              </a:ext>
            </a:extLst>
          </p:cNvPr>
          <p:cNvSpPr txBox="1"/>
          <p:nvPr/>
        </p:nvSpPr>
        <p:spPr>
          <a:xfrm>
            <a:off x="402956" y="154983"/>
            <a:ext cx="111437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XLAG </a:t>
            </a:r>
            <a:r>
              <a:rPr lang="fr-F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(THELEN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Patient 1 </a:t>
            </a:r>
            <a:endParaRPr lang="fr-FR" sz="2400" b="1" dirty="0"/>
          </a:p>
        </p:txBody>
      </p:sp>
    </p:spTree>
    <p:extLst>
      <p:ext uri="{BB962C8B-B14F-4D97-AF65-F5344CB8AC3E}">
        <p14:creationId xmlns:p14="http://schemas.microsoft.com/office/powerpoint/2010/main" val="12704317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 8">
            <a:extLst>
              <a:ext uri="{FF2B5EF4-FFF2-40B4-BE49-F238E27FC236}">
                <a16:creationId xmlns:a16="http://schemas.microsoft.com/office/drawing/2014/main" id="{942F682D-A5FC-AB44-A520-32E662FA01BC}"/>
              </a:ext>
            </a:extLst>
          </p:cNvPr>
          <p:cNvPicPr>
            <a:picLocks/>
          </p:cNvPicPr>
          <p:nvPr/>
        </p:nvPicPr>
        <p:blipFill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22553" y="1602355"/>
            <a:ext cx="3600000" cy="360000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DB2284C6-0E7A-9F40-A663-2A9228B50DDF}"/>
              </a:ext>
            </a:extLst>
          </p:cNvPr>
          <p:cNvPicPr>
            <a:picLocks/>
          </p:cNvPicPr>
          <p:nvPr/>
        </p:nvPicPr>
        <p:blipFill>
          <a:blip r:embed="rId4" cstate="email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2956" y="1577341"/>
            <a:ext cx="3600000" cy="360000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90BFDBC1-233D-4344-912E-967CF821924E}"/>
              </a:ext>
            </a:extLst>
          </p:cNvPr>
          <p:cNvPicPr>
            <a:picLocks/>
          </p:cNvPicPr>
          <p:nvPr/>
        </p:nvPicPr>
        <p:blipFill>
          <a:blip r:embed="rId6" cstate="email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24135" y="1577341"/>
            <a:ext cx="3600000" cy="3600000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EBF3674E-4F97-FF44-B283-43CDDAB3D122}"/>
              </a:ext>
            </a:extLst>
          </p:cNvPr>
          <p:cNvSpPr txBox="1"/>
          <p:nvPr/>
        </p:nvSpPr>
        <p:spPr>
          <a:xfrm>
            <a:off x="402956" y="154983"/>
            <a:ext cx="111437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XLAG </a:t>
            </a:r>
            <a:r>
              <a:rPr lang="fr-F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 – B09/500 (</a:t>
            </a:r>
            <a:r>
              <a:rPr lang="fr-BE" sz="2400" b="1" dirty="0"/>
              <a:t>Daniela </a:t>
            </a:r>
            <a:r>
              <a:rPr lang="fr-BE" sz="2400" b="1" dirty="0" err="1"/>
              <a:t>Bondesan</a:t>
            </a:r>
            <a:r>
              <a:rPr lang="fr-BE" sz="2400" b="1" dirty="0"/>
              <a:t>, </a:t>
            </a:r>
            <a:r>
              <a:rPr lang="fr-F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 )</a:t>
            </a:r>
          </a:p>
          <a:p>
            <a:pPr algn="ctr"/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Patient 2 </a:t>
            </a:r>
            <a:endParaRPr lang="fr-FR" sz="2400" b="1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7EF7444B-A496-1C4D-B28F-202C84E59253}"/>
              </a:ext>
            </a:extLst>
          </p:cNvPr>
          <p:cNvSpPr txBox="1"/>
          <p:nvPr/>
        </p:nvSpPr>
        <p:spPr>
          <a:xfrm>
            <a:off x="402956" y="1577341"/>
            <a:ext cx="8445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E370DFC-C4BD-A14B-8D44-DF06592A2024}"/>
              </a:ext>
            </a:extLst>
          </p:cNvPr>
          <p:cNvSpPr txBox="1"/>
          <p:nvPr/>
        </p:nvSpPr>
        <p:spPr>
          <a:xfrm>
            <a:off x="4215453" y="1600159"/>
            <a:ext cx="3600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-PKCɒ</a:t>
            </a:r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fr-F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2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</a:t>
            </a:r>
            <a:r>
              <a:rPr lang="fr-F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638)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D19CC8A5-6AC7-A94D-B187-7359F214E5B8}"/>
              </a:ext>
            </a:extLst>
          </p:cNvPr>
          <p:cNvSpPr txBox="1"/>
          <p:nvPr/>
        </p:nvSpPr>
        <p:spPr>
          <a:xfrm>
            <a:off x="8013871" y="1600159"/>
            <a:ext cx="360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B52A8CFE-39B6-DA4C-9DC9-1161E990BC5D}"/>
              </a:ext>
            </a:extLst>
          </p:cNvPr>
          <p:cNvSpPr txBox="1"/>
          <p:nvPr/>
        </p:nvSpPr>
        <p:spPr>
          <a:xfrm>
            <a:off x="402956" y="5200159"/>
            <a:ext cx="1744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cale</a:t>
            </a:r>
            <a:r>
              <a:rPr lang="fr-FR" dirty="0"/>
              <a:t> bar= 10µm</a:t>
            </a:r>
          </a:p>
        </p:txBody>
      </p:sp>
    </p:spTree>
    <p:extLst>
      <p:ext uri="{BB962C8B-B14F-4D97-AF65-F5344CB8AC3E}">
        <p14:creationId xmlns:p14="http://schemas.microsoft.com/office/powerpoint/2010/main" val="7220076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 11">
            <a:extLst>
              <a:ext uri="{FF2B5EF4-FFF2-40B4-BE49-F238E27FC236}">
                <a16:creationId xmlns:a16="http://schemas.microsoft.com/office/drawing/2014/main" id="{680636BD-6EBA-2A4F-8F92-D7AF29293DFA}"/>
              </a:ext>
            </a:extLst>
          </p:cNvPr>
          <p:cNvPicPr>
            <a:picLocks/>
          </p:cNvPicPr>
          <p:nvPr/>
        </p:nvPicPr>
        <p:blipFill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946755" y="1588838"/>
            <a:ext cx="3600000" cy="3600000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65F0AC86-9558-1045-9781-E523DB8B19CD}"/>
              </a:ext>
            </a:extLst>
          </p:cNvPr>
          <p:cNvPicPr>
            <a:picLocks/>
          </p:cNvPicPr>
          <p:nvPr/>
        </p:nvPicPr>
        <p:blipFill>
          <a:blip r:embed="rId4" cstate="email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9919" y="1600159"/>
            <a:ext cx="3600000" cy="3600000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9532D44A-A7E5-9140-9C79-6C6F7F81F5EE}"/>
              </a:ext>
            </a:extLst>
          </p:cNvPr>
          <p:cNvPicPr>
            <a:picLocks/>
          </p:cNvPicPr>
          <p:nvPr/>
        </p:nvPicPr>
        <p:blipFill>
          <a:blip r:embed="rId6" cstate="email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48337" y="1600159"/>
            <a:ext cx="3600000" cy="3600000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EBF3674E-4F97-FF44-B283-43CDDAB3D122}"/>
              </a:ext>
            </a:extLst>
          </p:cNvPr>
          <p:cNvSpPr txBox="1"/>
          <p:nvPr/>
        </p:nvSpPr>
        <p:spPr>
          <a:xfrm>
            <a:off x="402956" y="154983"/>
            <a:ext cx="111437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XLAG </a:t>
            </a:r>
            <a:r>
              <a:rPr lang="fr-F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Osp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Bellaria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 90/2821 FB (male)</a:t>
            </a:r>
          </a:p>
          <a:p>
            <a:pPr algn="ctr"/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Patient 3 </a:t>
            </a:r>
            <a:endParaRPr lang="fr-FR" sz="2400" b="1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7EF7444B-A496-1C4D-B28F-202C84E59253}"/>
              </a:ext>
            </a:extLst>
          </p:cNvPr>
          <p:cNvSpPr txBox="1"/>
          <p:nvPr/>
        </p:nvSpPr>
        <p:spPr>
          <a:xfrm>
            <a:off x="402956" y="1577341"/>
            <a:ext cx="8445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E370DFC-C4BD-A14B-8D44-DF06592A2024}"/>
              </a:ext>
            </a:extLst>
          </p:cNvPr>
          <p:cNvSpPr txBox="1"/>
          <p:nvPr/>
        </p:nvSpPr>
        <p:spPr>
          <a:xfrm>
            <a:off x="4215453" y="1600159"/>
            <a:ext cx="3600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-PKCɒ</a:t>
            </a:r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fr-F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2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</a:t>
            </a:r>
            <a:r>
              <a:rPr lang="fr-F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638)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D19CC8A5-6AC7-A94D-B187-7359F214E5B8}"/>
              </a:ext>
            </a:extLst>
          </p:cNvPr>
          <p:cNvSpPr txBox="1"/>
          <p:nvPr/>
        </p:nvSpPr>
        <p:spPr>
          <a:xfrm>
            <a:off x="8013871" y="1600159"/>
            <a:ext cx="360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1494FAA4-A9F2-6144-AE4B-D3042D511702}"/>
              </a:ext>
            </a:extLst>
          </p:cNvPr>
          <p:cNvSpPr txBox="1"/>
          <p:nvPr/>
        </p:nvSpPr>
        <p:spPr>
          <a:xfrm>
            <a:off x="402956" y="5200159"/>
            <a:ext cx="1744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cale</a:t>
            </a:r>
            <a:r>
              <a:rPr lang="fr-FR" dirty="0"/>
              <a:t> bar= 10µm</a:t>
            </a:r>
          </a:p>
        </p:txBody>
      </p:sp>
    </p:spTree>
    <p:extLst>
      <p:ext uri="{BB962C8B-B14F-4D97-AF65-F5344CB8AC3E}">
        <p14:creationId xmlns:p14="http://schemas.microsoft.com/office/powerpoint/2010/main" val="188837032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</TotalTime>
  <Words>174</Words>
  <Application>Microsoft Macintosh PowerPoint</Application>
  <PresentationFormat>Grand écran</PresentationFormat>
  <Paragraphs>30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24</cp:revision>
  <dcterms:created xsi:type="dcterms:W3CDTF">2019-07-03T08:28:07Z</dcterms:created>
  <dcterms:modified xsi:type="dcterms:W3CDTF">2020-05-17T15:11:21Z</dcterms:modified>
</cp:coreProperties>
</file>